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0058400" cy="10439400"/>
  <p:notesSz cx="6858000" cy="9144000"/>
  <p:defaultTextStyle>
    <a:defPPr>
      <a:defRPr lang="de-DE"/>
    </a:defPPr>
    <a:lvl1pPr marL="0" algn="l" defTabSz="130620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1pPr>
    <a:lvl2pPr marL="653101" algn="l" defTabSz="130620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2pPr>
    <a:lvl3pPr marL="1306202" algn="l" defTabSz="130620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3pPr>
    <a:lvl4pPr marL="1959303" algn="l" defTabSz="130620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4pPr>
    <a:lvl5pPr marL="2612404" algn="l" defTabSz="130620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5pPr>
    <a:lvl6pPr marL="3265505" algn="l" defTabSz="130620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6pPr>
    <a:lvl7pPr marL="3918606" algn="l" defTabSz="130620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7pPr>
    <a:lvl8pPr marL="4571707" algn="l" defTabSz="130620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8pPr>
    <a:lvl9pPr marL="5224808" algn="l" defTabSz="130620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88" userDrawn="1">
          <p15:clr>
            <a:srgbClr val="A4A3A4"/>
          </p15:clr>
        </p15:guide>
        <p15:guide id="2" pos="31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2484" y="72"/>
      </p:cViewPr>
      <p:guideLst>
        <p:guide orient="horz" pos="3288"/>
        <p:guide pos="316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54380" y="3242982"/>
            <a:ext cx="8549640" cy="2237704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08760" y="5915660"/>
            <a:ext cx="7040880" cy="266784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326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652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978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304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630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1956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7282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2608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FA9B-AE7E-47BC-8E0D-D530FD2E56A5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7CDFD-76E9-4616-8DBF-5CBA89C7BC39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FA9B-AE7E-47BC-8E0D-D530FD2E56A5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7CDFD-76E9-4616-8DBF-5CBA89C7BC39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7292340" y="418062"/>
            <a:ext cx="2263140" cy="8907321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502920" y="418062"/>
            <a:ext cx="6621780" cy="8907321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FA9B-AE7E-47BC-8E0D-D530FD2E56A5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7CDFD-76E9-4616-8DBF-5CBA89C7BC39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FA9B-AE7E-47BC-8E0D-D530FD2E56A5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7CDFD-76E9-4616-8DBF-5CBA89C7BC39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94545" y="6708282"/>
            <a:ext cx="8549640" cy="2073381"/>
          </a:xfrm>
        </p:spPr>
        <p:txBody>
          <a:bodyPr anchor="t"/>
          <a:lstStyle>
            <a:lvl1pPr algn="l">
              <a:defRPr sz="4648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94545" y="4424665"/>
            <a:ext cx="8549640" cy="2283618"/>
          </a:xfrm>
        </p:spPr>
        <p:txBody>
          <a:bodyPr anchor="b"/>
          <a:lstStyle>
            <a:lvl1pPr marL="0" indent="0">
              <a:buNone/>
              <a:defRPr sz="2365">
                <a:solidFill>
                  <a:schemeClr val="tx1">
                    <a:tint val="75000"/>
                  </a:schemeClr>
                </a:solidFill>
              </a:defRPr>
            </a:lvl1pPr>
            <a:lvl2pPr marL="532604" indent="0">
              <a:buNone/>
              <a:defRPr sz="2120">
                <a:solidFill>
                  <a:schemeClr val="tx1">
                    <a:tint val="75000"/>
                  </a:schemeClr>
                </a:solidFill>
              </a:defRPr>
            </a:lvl2pPr>
            <a:lvl3pPr marL="1065208" indent="0">
              <a:buNone/>
              <a:defRPr sz="1876">
                <a:solidFill>
                  <a:schemeClr val="tx1">
                    <a:tint val="75000"/>
                  </a:schemeClr>
                </a:solidFill>
              </a:defRPr>
            </a:lvl3pPr>
            <a:lvl4pPr marL="1597812" indent="0">
              <a:buNone/>
              <a:defRPr sz="1631">
                <a:solidFill>
                  <a:schemeClr val="tx1">
                    <a:tint val="75000"/>
                  </a:schemeClr>
                </a:solidFill>
              </a:defRPr>
            </a:lvl4pPr>
            <a:lvl5pPr marL="2130415" indent="0">
              <a:buNone/>
              <a:defRPr sz="1631">
                <a:solidFill>
                  <a:schemeClr val="tx1">
                    <a:tint val="75000"/>
                  </a:schemeClr>
                </a:solidFill>
              </a:defRPr>
            </a:lvl5pPr>
            <a:lvl6pPr marL="2663019" indent="0">
              <a:buNone/>
              <a:defRPr sz="1631">
                <a:solidFill>
                  <a:schemeClr val="tx1">
                    <a:tint val="75000"/>
                  </a:schemeClr>
                </a:solidFill>
              </a:defRPr>
            </a:lvl6pPr>
            <a:lvl7pPr marL="3195623" indent="0">
              <a:buNone/>
              <a:defRPr sz="1631">
                <a:solidFill>
                  <a:schemeClr val="tx1">
                    <a:tint val="75000"/>
                  </a:schemeClr>
                </a:solidFill>
              </a:defRPr>
            </a:lvl7pPr>
            <a:lvl8pPr marL="3728227" indent="0">
              <a:buNone/>
              <a:defRPr sz="1631">
                <a:solidFill>
                  <a:schemeClr val="tx1">
                    <a:tint val="75000"/>
                  </a:schemeClr>
                </a:solidFill>
              </a:defRPr>
            </a:lvl8pPr>
            <a:lvl9pPr marL="4260831" indent="0">
              <a:buNone/>
              <a:defRPr sz="163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FA9B-AE7E-47BC-8E0D-D530FD2E56A5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7CDFD-76E9-4616-8DBF-5CBA89C7BC39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502920" y="2435861"/>
            <a:ext cx="4442460" cy="6889522"/>
          </a:xfrm>
        </p:spPr>
        <p:txBody>
          <a:bodyPr/>
          <a:lstStyle>
            <a:lvl1pPr>
              <a:defRPr sz="3262"/>
            </a:lvl1pPr>
            <a:lvl2pPr>
              <a:defRPr sz="2773"/>
            </a:lvl2pPr>
            <a:lvl3pPr>
              <a:defRPr sz="2365"/>
            </a:lvl3pPr>
            <a:lvl4pPr>
              <a:defRPr sz="2120"/>
            </a:lvl4pPr>
            <a:lvl5pPr>
              <a:defRPr sz="2120"/>
            </a:lvl5pPr>
            <a:lvl6pPr>
              <a:defRPr sz="2120"/>
            </a:lvl6pPr>
            <a:lvl7pPr>
              <a:defRPr sz="2120"/>
            </a:lvl7pPr>
            <a:lvl8pPr>
              <a:defRPr sz="2120"/>
            </a:lvl8pPr>
            <a:lvl9pPr>
              <a:defRPr sz="212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5113020" y="2435861"/>
            <a:ext cx="4442460" cy="6889522"/>
          </a:xfrm>
        </p:spPr>
        <p:txBody>
          <a:bodyPr/>
          <a:lstStyle>
            <a:lvl1pPr>
              <a:defRPr sz="3262"/>
            </a:lvl1pPr>
            <a:lvl2pPr>
              <a:defRPr sz="2773"/>
            </a:lvl2pPr>
            <a:lvl3pPr>
              <a:defRPr sz="2365"/>
            </a:lvl3pPr>
            <a:lvl4pPr>
              <a:defRPr sz="2120"/>
            </a:lvl4pPr>
            <a:lvl5pPr>
              <a:defRPr sz="2120"/>
            </a:lvl5pPr>
            <a:lvl6pPr>
              <a:defRPr sz="2120"/>
            </a:lvl6pPr>
            <a:lvl7pPr>
              <a:defRPr sz="2120"/>
            </a:lvl7pPr>
            <a:lvl8pPr>
              <a:defRPr sz="2120"/>
            </a:lvl8pPr>
            <a:lvl9pPr>
              <a:defRPr sz="212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FA9B-AE7E-47BC-8E0D-D530FD2E56A5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7CDFD-76E9-4616-8DBF-5CBA89C7BC39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02921" y="2336784"/>
            <a:ext cx="4444207" cy="973860"/>
          </a:xfrm>
        </p:spPr>
        <p:txBody>
          <a:bodyPr anchor="b"/>
          <a:lstStyle>
            <a:lvl1pPr marL="0" indent="0">
              <a:buNone/>
              <a:defRPr sz="2773" b="1"/>
            </a:lvl1pPr>
            <a:lvl2pPr marL="532604" indent="0">
              <a:buNone/>
              <a:defRPr sz="2365" b="1"/>
            </a:lvl2pPr>
            <a:lvl3pPr marL="1065208" indent="0">
              <a:buNone/>
              <a:defRPr sz="2120" b="1"/>
            </a:lvl3pPr>
            <a:lvl4pPr marL="1597812" indent="0">
              <a:buNone/>
              <a:defRPr sz="1876" b="1"/>
            </a:lvl4pPr>
            <a:lvl5pPr marL="2130415" indent="0">
              <a:buNone/>
              <a:defRPr sz="1876" b="1"/>
            </a:lvl5pPr>
            <a:lvl6pPr marL="2663019" indent="0">
              <a:buNone/>
              <a:defRPr sz="1876" b="1"/>
            </a:lvl6pPr>
            <a:lvl7pPr marL="3195623" indent="0">
              <a:buNone/>
              <a:defRPr sz="1876" b="1"/>
            </a:lvl7pPr>
            <a:lvl8pPr marL="3728227" indent="0">
              <a:buNone/>
              <a:defRPr sz="1876" b="1"/>
            </a:lvl8pPr>
            <a:lvl9pPr marL="4260831" indent="0">
              <a:buNone/>
              <a:defRPr sz="1876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502921" y="3310644"/>
            <a:ext cx="4444207" cy="6014738"/>
          </a:xfrm>
        </p:spPr>
        <p:txBody>
          <a:bodyPr/>
          <a:lstStyle>
            <a:lvl1pPr>
              <a:defRPr sz="2773"/>
            </a:lvl1pPr>
            <a:lvl2pPr>
              <a:defRPr sz="2365"/>
            </a:lvl2pPr>
            <a:lvl3pPr>
              <a:defRPr sz="2120"/>
            </a:lvl3pPr>
            <a:lvl4pPr>
              <a:defRPr sz="1876"/>
            </a:lvl4pPr>
            <a:lvl5pPr>
              <a:defRPr sz="1876"/>
            </a:lvl5pPr>
            <a:lvl6pPr>
              <a:defRPr sz="1876"/>
            </a:lvl6pPr>
            <a:lvl7pPr>
              <a:defRPr sz="1876"/>
            </a:lvl7pPr>
            <a:lvl8pPr>
              <a:defRPr sz="1876"/>
            </a:lvl8pPr>
            <a:lvl9pPr>
              <a:defRPr sz="1876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5109529" y="2336784"/>
            <a:ext cx="4445953" cy="973860"/>
          </a:xfrm>
        </p:spPr>
        <p:txBody>
          <a:bodyPr anchor="b"/>
          <a:lstStyle>
            <a:lvl1pPr marL="0" indent="0">
              <a:buNone/>
              <a:defRPr sz="2773" b="1"/>
            </a:lvl1pPr>
            <a:lvl2pPr marL="532604" indent="0">
              <a:buNone/>
              <a:defRPr sz="2365" b="1"/>
            </a:lvl2pPr>
            <a:lvl3pPr marL="1065208" indent="0">
              <a:buNone/>
              <a:defRPr sz="2120" b="1"/>
            </a:lvl3pPr>
            <a:lvl4pPr marL="1597812" indent="0">
              <a:buNone/>
              <a:defRPr sz="1876" b="1"/>
            </a:lvl4pPr>
            <a:lvl5pPr marL="2130415" indent="0">
              <a:buNone/>
              <a:defRPr sz="1876" b="1"/>
            </a:lvl5pPr>
            <a:lvl6pPr marL="2663019" indent="0">
              <a:buNone/>
              <a:defRPr sz="1876" b="1"/>
            </a:lvl6pPr>
            <a:lvl7pPr marL="3195623" indent="0">
              <a:buNone/>
              <a:defRPr sz="1876" b="1"/>
            </a:lvl7pPr>
            <a:lvl8pPr marL="3728227" indent="0">
              <a:buNone/>
              <a:defRPr sz="1876" b="1"/>
            </a:lvl8pPr>
            <a:lvl9pPr marL="4260831" indent="0">
              <a:buNone/>
              <a:defRPr sz="1876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5109529" y="3310644"/>
            <a:ext cx="4445953" cy="6014738"/>
          </a:xfrm>
        </p:spPr>
        <p:txBody>
          <a:bodyPr/>
          <a:lstStyle>
            <a:lvl1pPr>
              <a:defRPr sz="2773"/>
            </a:lvl1pPr>
            <a:lvl2pPr>
              <a:defRPr sz="2365"/>
            </a:lvl2pPr>
            <a:lvl3pPr>
              <a:defRPr sz="2120"/>
            </a:lvl3pPr>
            <a:lvl4pPr>
              <a:defRPr sz="1876"/>
            </a:lvl4pPr>
            <a:lvl5pPr>
              <a:defRPr sz="1876"/>
            </a:lvl5pPr>
            <a:lvl6pPr>
              <a:defRPr sz="1876"/>
            </a:lvl6pPr>
            <a:lvl7pPr>
              <a:defRPr sz="1876"/>
            </a:lvl7pPr>
            <a:lvl8pPr>
              <a:defRPr sz="1876"/>
            </a:lvl8pPr>
            <a:lvl9pPr>
              <a:defRPr sz="1876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FA9B-AE7E-47BC-8E0D-D530FD2E56A5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7CDFD-76E9-4616-8DBF-5CBA89C7BC39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FA9B-AE7E-47BC-8E0D-D530FD2E56A5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7CDFD-76E9-4616-8DBF-5CBA89C7BC39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FA9B-AE7E-47BC-8E0D-D530FD2E56A5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7CDFD-76E9-4616-8DBF-5CBA89C7BC39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02921" y="415643"/>
            <a:ext cx="3309145" cy="1768898"/>
          </a:xfrm>
        </p:spPr>
        <p:txBody>
          <a:bodyPr anchor="b"/>
          <a:lstStyle>
            <a:lvl1pPr algn="l">
              <a:defRPr sz="2365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932556" y="415644"/>
            <a:ext cx="5622925" cy="8909739"/>
          </a:xfrm>
        </p:spPr>
        <p:txBody>
          <a:bodyPr/>
          <a:lstStyle>
            <a:lvl1pPr>
              <a:defRPr sz="3751"/>
            </a:lvl1pPr>
            <a:lvl2pPr>
              <a:defRPr sz="3262"/>
            </a:lvl2pPr>
            <a:lvl3pPr>
              <a:defRPr sz="2773"/>
            </a:lvl3pPr>
            <a:lvl4pPr>
              <a:defRPr sz="2365"/>
            </a:lvl4pPr>
            <a:lvl5pPr>
              <a:defRPr sz="2365"/>
            </a:lvl5pPr>
            <a:lvl6pPr>
              <a:defRPr sz="2365"/>
            </a:lvl6pPr>
            <a:lvl7pPr>
              <a:defRPr sz="2365"/>
            </a:lvl7pPr>
            <a:lvl8pPr>
              <a:defRPr sz="2365"/>
            </a:lvl8pPr>
            <a:lvl9pPr>
              <a:defRPr sz="2365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502921" y="2184543"/>
            <a:ext cx="3309145" cy="7140840"/>
          </a:xfrm>
        </p:spPr>
        <p:txBody>
          <a:bodyPr/>
          <a:lstStyle>
            <a:lvl1pPr marL="0" indent="0">
              <a:buNone/>
              <a:defRPr sz="1631"/>
            </a:lvl1pPr>
            <a:lvl2pPr marL="532604" indent="0">
              <a:buNone/>
              <a:defRPr sz="1386"/>
            </a:lvl2pPr>
            <a:lvl3pPr marL="1065208" indent="0">
              <a:buNone/>
              <a:defRPr sz="1142"/>
            </a:lvl3pPr>
            <a:lvl4pPr marL="1597812" indent="0">
              <a:buNone/>
              <a:defRPr sz="979"/>
            </a:lvl4pPr>
            <a:lvl5pPr marL="2130415" indent="0">
              <a:buNone/>
              <a:defRPr sz="979"/>
            </a:lvl5pPr>
            <a:lvl6pPr marL="2663019" indent="0">
              <a:buNone/>
              <a:defRPr sz="979"/>
            </a:lvl6pPr>
            <a:lvl7pPr marL="3195623" indent="0">
              <a:buNone/>
              <a:defRPr sz="979"/>
            </a:lvl7pPr>
            <a:lvl8pPr marL="3728227" indent="0">
              <a:buNone/>
              <a:defRPr sz="979"/>
            </a:lvl8pPr>
            <a:lvl9pPr marL="4260831" indent="0">
              <a:buNone/>
              <a:defRPr sz="979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FA9B-AE7E-47BC-8E0D-D530FD2E56A5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7CDFD-76E9-4616-8DBF-5CBA89C7BC39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971517" y="7307581"/>
            <a:ext cx="6035040" cy="862701"/>
          </a:xfrm>
        </p:spPr>
        <p:txBody>
          <a:bodyPr anchor="b"/>
          <a:lstStyle>
            <a:lvl1pPr algn="l">
              <a:defRPr sz="2365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971517" y="932779"/>
            <a:ext cx="6035040" cy="6263640"/>
          </a:xfrm>
        </p:spPr>
        <p:txBody>
          <a:bodyPr/>
          <a:lstStyle>
            <a:lvl1pPr marL="0" indent="0">
              <a:buNone/>
              <a:defRPr sz="3751"/>
            </a:lvl1pPr>
            <a:lvl2pPr marL="532604" indent="0">
              <a:buNone/>
              <a:defRPr sz="3262"/>
            </a:lvl2pPr>
            <a:lvl3pPr marL="1065208" indent="0">
              <a:buNone/>
              <a:defRPr sz="2773"/>
            </a:lvl3pPr>
            <a:lvl4pPr marL="1597812" indent="0">
              <a:buNone/>
              <a:defRPr sz="2365"/>
            </a:lvl4pPr>
            <a:lvl5pPr marL="2130415" indent="0">
              <a:buNone/>
              <a:defRPr sz="2365"/>
            </a:lvl5pPr>
            <a:lvl6pPr marL="2663019" indent="0">
              <a:buNone/>
              <a:defRPr sz="2365"/>
            </a:lvl6pPr>
            <a:lvl7pPr marL="3195623" indent="0">
              <a:buNone/>
              <a:defRPr sz="2365"/>
            </a:lvl7pPr>
            <a:lvl8pPr marL="3728227" indent="0">
              <a:buNone/>
              <a:defRPr sz="2365"/>
            </a:lvl8pPr>
            <a:lvl9pPr marL="4260831" indent="0">
              <a:buNone/>
              <a:defRPr sz="2365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971517" y="8170282"/>
            <a:ext cx="6035040" cy="1225179"/>
          </a:xfrm>
        </p:spPr>
        <p:txBody>
          <a:bodyPr/>
          <a:lstStyle>
            <a:lvl1pPr marL="0" indent="0">
              <a:buNone/>
              <a:defRPr sz="1631"/>
            </a:lvl1pPr>
            <a:lvl2pPr marL="532604" indent="0">
              <a:buNone/>
              <a:defRPr sz="1386"/>
            </a:lvl2pPr>
            <a:lvl3pPr marL="1065208" indent="0">
              <a:buNone/>
              <a:defRPr sz="1142"/>
            </a:lvl3pPr>
            <a:lvl4pPr marL="1597812" indent="0">
              <a:buNone/>
              <a:defRPr sz="979"/>
            </a:lvl4pPr>
            <a:lvl5pPr marL="2130415" indent="0">
              <a:buNone/>
              <a:defRPr sz="979"/>
            </a:lvl5pPr>
            <a:lvl6pPr marL="2663019" indent="0">
              <a:buNone/>
              <a:defRPr sz="979"/>
            </a:lvl6pPr>
            <a:lvl7pPr marL="3195623" indent="0">
              <a:buNone/>
              <a:defRPr sz="979"/>
            </a:lvl7pPr>
            <a:lvl8pPr marL="3728227" indent="0">
              <a:buNone/>
              <a:defRPr sz="979"/>
            </a:lvl8pPr>
            <a:lvl9pPr marL="4260831" indent="0">
              <a:buNone/>
              <a:defRPr sz="979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FA9B-AE7E-47BC-8E0D-D530FD2E56A5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7CDFD-76E9-4616-8DBF-5CBA89C7BC39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502920" y="418060"/>
            <a:ext cx="9052560" cy="1739900"/>
          </a:xfrm>
          <a:prstGeom prst="rect">
            <a:avLst/>
          </a:prstGeom>
        </p:spPr>
        <p:txBody>
          <a:bodyPr vert="horz" lIns="130620" tIns="65310" rIns="130620" bIns="6531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02920" y="2435861"/>
            <a:ext cx="9052560" cy="6889522"/>
          </a:xfrm>
          <a:prstGeom prst="rect">
            <a:avLst/>
          </a:prstGeom>
        </p:spPr>
        <p:txBody>
          <a:bodyPr vert="horz" lIns="130620" tIns="65310" rIns="130620" bIns="6531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502920" y="9675779"/>
            <a:ext cx="2346960" cy="555801"/>
          </a:xfrm>
          <a:prstGeom prst="rect">
            <a:avLst/>
          </a:prstGeom>
        </p:spPr>
        <p:txBody>
          <a:bodyPr vert="horz" lIns="130620" tIns="65310" rIns="130620" bIns="65310" rtlCol="0" anchor="ctr"/>
          <a:lstStyle>
            <a:lvl1pPr algn="l">
              <a:defRPr sz="13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DFA9B-AE7E-47BC-8E0D-D530FD2E56A5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436620" y="9675779"/>
            <a:ext cx="3185160" cy="555801"/>
          </a:xfrm>
          <a:prstGeom prst="rect">
            <a:avLst/>
          </a:prstGeom>
        </p:spPr>
        <p:txBody>
          <a:bodyPr vert="horz" lIns="130620" tIns="65310" rIns="130620" bIns="65310" rtlCol="0" anchor="ctr"/>
          <a:lstStyle>
            <a:lvl1pPr algn="ctr">
              <a:defRPr sz="13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7208520" y="9675779"/>
            <a:ext cx="2346960" cy="555801"/>
          </a:xfrm>
          <a:prstGeom prst="rect">
            <a:avLst/>
          </a:prstGeom>
        </p:spPr>
        <p:txBody>
          <a:bodyPr vert="horz" lIns="130620" tIns="65310" rIns="130620" bIns="65310" rtlCol="0" anchor="ctr"/>
          <a:lstStyle>
            <a:lvl1pPr algn="r">
              <a:defRPr sz="13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A7CDFD-76E9-4616-8DBF-5CBA89C7BC39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65208" rtl="0" eaLnBrk="1" latinLnBrk="0" hangingPunct="1">
        <a:spcBef>
          <a:spcPct val="0"/>
        </a:spcBef>
        <a:buNone/>
        <a:defRPr sz="505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99453" indent="-399453" algn="l" defTabSz="1065208" rtl="0" eaLnBrk="1" latinLnBrk="0" hangingPunct="1">
        <a:spcBef>
          <a:spcPct val="20000"/>
        </a:spcBef>
        <a:buFont typeface="Arial" pitchFamily="34" charset="0"/>
        <a:buChar char="•"/>
        <a:defRPr sz="3751" kern="1200">
          <a:solidFill>
            <a:schemeClr val="tx1"/>
          </a:solidFill>
          <a:latin typeface="+mn-lt"/>
          <a:ea typeface="+mn-ea"/>
          <a:cs typeface="+mn-cs"/>
        </a:defRPr>
      </a:lvl1pPr>
      <a:lvl2pPr marL="865481" indent="-332877" algn="l" defTabSz="1065208" rtl="0" eaLnBrk="1" latinLnBrk="0" hangingPunct="1">
        <a:spcBef>
          <a:spcPct val="20000"/>
        </a:spcBef>
        <a:buFont typeface="Arial" pitchFamily="34" charset="0"/>
        <a:buChar char="–"/>
        <a:defRPr sz="3262" kern="1200">
          <a:solidFill>
            <a:schemeClr val="tx1"/>
          </a:solidFill>
          <a:latin typeface="+mn-lt"/>
          <a:ea typeface="+mn-ea"/>
          <a:cs typeface="+mn-cs"/>
        </a:defRPr>
      </a:lvl2pPr>
      <a:lvl3pPr marL="1331510" indent="-266302" algn="l" defTabSz="1065208" rtl="0" eaLnBrk="1" latinLnBrk="0" hangingPunct="1">
        <a:spcBef>
          <a:spcPct val="20000"/>
        </a:spcBef>
        <a:buFont typeface="Arial" pitchFamily="34" charset="0"/>
        <a:buChar char="•"/>
        <a:defRPr sz="2773" kern="1200">
          <a:solidFill>
            <a:schemeClr val="tx1"/>
          </a:solidFill>
          <a:latin typeface="+mn-lt"/>
          <a:ea typeface="+mn-ea"/>
          <a:cs typeface="+mn-cs"/>
        </a:defRPr>
      </a:lvl3pPr>
      <a:lvl4pPr marL="1864114" indent="-266302" algn="l" defTabSz="1065208" rtl="0" eaLnBrk="1" latinLnBrk="0" hangingPunct="1">
        <a:spcBef>
          <a:spcPct val="20000"/>
        </a:spcBef>
        <a:buFont typeface="Arial" pitchFamily="34" charset="0"/>
        <a:buChar char="–"/>
        <a:defRPr sz="2365" kern="1200">
          <a:solidFill>
            <a:schemeClr val="tx1"/>
          </a:solidFill>
          <a:latin typeface="+mn-lt"/>
          <a:ea typeface="+mn-ea"/>
          <a:cs typeface="+mn-cs"/>
        </a:defRPr>
      </a:lvl4pPr>
      <a:lvl5pPr marL="2396718" indent="-266302" algn="l" defTabSz="1065208" rtl="0" eaLnBrk="1" latinLnBrk="0" hangingPunct="1">
        <a:spcBef>
          <a:spcPct val="20000"/>
        </a:spcBef>
        <a:buFont typeface="Arial" pitchFamily="34" charset="0"/>
        <a:buChar char="»"/>
        <a:defRPr sz="2365" kern="1200">
          <a:solidFill>
            <a:schemeClr val="tx1"/>
          </a:solidFill>
          <a:latin typeface="+mn-lt"/>
          <a:ea typeface="+mn-ea"/>
          <a:cs typeface="+mn-cs"/>
        </a:defRPr>
      </a:lvl5pPr>
      <a:lvl6pPr marL="2929322" indent="-266302" algn="l" defTabSz="1065208" rtl="0" eaLnBrk="1" latinLnBrk="0" hangingPunct="1">
        <a:spcBef>
          <a:spcPct val="20000"/>
        </a:spcBef>
        <a:buFont typeface="Arial" pitchFamily="34" charset="0"/>
        <a:buChar char="•"/>
        <a:defRPr sz="2365" kern="1200">
          <a:solidFill>
            <a:schemeClr val="tx1"/>
          </a:solidFill>
          <a:latin typeface="+mn-lt"/>
          <a:ea typeface="+mn-ea"/>
          <a:cs typeface="+mn-cs"/>
        </a:defRPr>
      </a:lvl6pPr>
      <a:lvl7pPr marL="3461926" indent="-266302" algn="l" defTabSz="1065208" rtl="0" eaLnBrk="1" latinLnBrk="0" hangingPunct="1">
        <a:spcBef>
          <a:spcPct val="20000"/>
        </a:spcBef>
        <a:buFont typeface="Arial" pitchFamily="34" charset="0"/>
        <a:buChar char="•"/>
        <a:defRPr sz="2365" kern="1200">
          <a:solidFill>
            <a:schemeClr val="tx1"/>
          </a:solidFill>
          <a:latin typeface="+mn-lt"/>
          <a:ea typeface="+mn-ea"/>
          <a:cs typeface="+mn-cs"/>
        </a:defRPr>
      </a:lvl7pPr>
      <a:lvl8pPr marL="3994529" indent="-266302" algn="l" defTabSz="1065208" rtl="0" eaLnBrk="1" latinLnBrk="0" hangingPunct="1">
        <a:spcBef>
          <a:spcPct val="20000"/>
        </a:spcBef>
        <a:buFont typeface="Arial" pitchFamily="34" charset="0"/>
        <a:buChar char="•"/>
        <a:defRPr sz="2365" kern="1200">
          <a:solidFill>
            <a:schemeClr val="tx1"/>
          </a:solidFill>
          <a:latin typeface="+mn-lt"/>
          <a:ea typeface="+mn-ea"/>
          <a:cs typeface="+mn-cs"/>
        </a:defRPr>
      </a:lvl8pPr>
      <a:lvl9pPr marL="4527133" indent="-266302" algn="l" defTabSz="1065208" rtl="0" eaLnBrk="1" latinLnBrk="0" hangingPunct="1">
        <a:spcBef>
          <a:spcPct val="20000"/>
        </a:spcBef>
        <a:buFont typeface="Arial" pitchFamily="34" charset="0"/>
        <a:buChar char="•"/>
        <a:defRPr sz="236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065208" rtl="0" eaLnBrk="1" latinLnBrk="0" hangingPunct="1">
        <a:defRPr sz="2120" kern="1200">
          <a:solidFill>
            <a:schemeClr val="tx1"/>
          </a:solidFill>
          <a:latin typeface="+mn-lt"/>
          <a:ea typeface="+mn-ea"/>
          <a:cs typeface="+mn-cs"/>
        </a:defRPr>
      </a:lvl1pPr>
      <a:lvl2pPr marL="532604" algn="l" defTabSz="1065208" rtl="0" eaLnBrk="1" latinLnBrk="0" hangingPunct="1">
        <a:defRPr sz="2120" kern="1200">
          <a:solidFill>
            <a:schemeClr val="tx1"/>
          </a:solidFill>
          <a:latin typeface="+mn-lt"/>
          <a:ea typeface="+mn-ea"/>
          <a:cs typeface="+mn-cs"/>
        </a:defRPr>
      </a:lvl2pPr>
      <a:lvl3pPr marL="1065208" algn="l" defTabSz="1065208" rtl="0" eaLnBrk="1" latinLnBrk="0" hangingPunct="1">
        <a:defRPr sz="2120" kern="1200">
          <a:solidFill>
            <a:schemeClr val="tx1"/>
          </a:solidFill>
          <a:latin typeface="+mn-lt"/>
          <a:ea typeface="+mn-ea"/>
          <a:cs typeface="+mn-cs"/>
        </a:defRPr>
      </a:lvl3pPr>
      <a:lvl4pPr marL="1597812" algn="l" defTabSz="1065208" rtl="0" eaLnBrk="1" latinLnBrk="0" hangingPunct="1">
        <a:defRPr sz="2120" kern="1200">
          <a:solidFill>
            <a:schemeClr val="tx1"/>
          </a:solidFill>
          <a:latin typeface="+mn-lt"/>
          <a:ea typeface="+mn-ea"/>
          <a:cs typeface="+mn-cs"/>
        </a:defRPr>
      </a:lvl4pPr>
      <a:lvl5pPr marL="2130415" algn="l" defTabSz="1065208" rtl="0" eaLnBrk="1" latinLnBrk="0" hangingPunct="1">
        <a:defRPr sz="2120" kern="1200">
          <a:solidFill>
            <a:schemeClr val="tx1"/>
          </a:solidFill>
          <a:latin typeface="+mn-lt"/>
          <a:ea typeface="+mn-ea"/>
          <a:cs typeface="+mn-cs"/>
        </a:defRPr>
      </a:lvl5pPr>
      <a:lvl6pPr marL="2663019" algn="l" defTabSz="1065208" rtl="0" eaLnBrk="1" latinLnBrk="0" hangingPunct="1">
        <a:defRPr sz="2120" kern="1200">
          <a:solidFill>
            <a:schemeClr val="tx1"/>
          </a:solidFill>
          <a:latin typeface="+mn-lt"/>
          <a:ea typeface="+mn-ea"/>
          <a:cs typeface="+mn-cs"/>
        </a:defRPr>
      </a:lvl6pPr>
      <a:lvl7pPr marL="3195623" algn="l" defTabSz="1065208" rtl="0" eaLnBrk="1" latinLnBrk="0" hangingPunct="1">
        <a:defRPr sz="2120" kern="1200">
          <a:solidFill>
            <a:schemeClr val="tx1"/>
          </a:solidFill>
          <a:latin typeface="+mn-lt"/>
          <a:ea typeface="+mn-ea"/>
          <a:cs typeface="+mn-cs"/>
        </a:defRPr>
      </a:lvl7pPr>
      <a:lvl8pPr marL="3728227" algn="l" defTabSz="1065208" rtl="0" eaLnBrk="1" latinLnBrk="0" hangingPunct="1">
        <a:defRPr sz="2120" kern="1200">
          <a:solidFill>
            <a:schemeClr val="tx1"/>
          </a:solidFill>
          <a:latin typeface="+mn-lt"/>
          <a:ea typeface="+mn-ea"/>
          <a:cs typeface="+mn-cs"/>
        </a:defRPr>
      </a:lvl8pPr>
      <a:lvl9pPr marL="4260831" algn="l" defTabSz="1065208" rtl="0" eaLnBrk="1" latinLnBrk="0" hangingPunct="1">
        <a:defRPr sz="21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Rechteck 65"/>
          <p:cNvSpPr/>
          <p:nvPr/>
        </p:nvSpPr>
        <p:spPr>
          <a:xfrm>
            <a:off x="3200399" y="3695700"/>
            <a:ext cx="2057400" cy="3429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7" name="Rechteck 66"/>
          <p:cNvSpPr/>
          <p:nvPr/>
        </p:nvSpPr>
        <p:spPr>
          <a:xfrm>
            <a:off x="990599" y="876300"/>
            <a:ext cx="2057400" cy="2667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8" name="Textfeld 67"/>
          <p:cNvSpPr txBox="1"/>
          <p:nvPr/>
        </p:nvSpPr>
        <p:spPr>
          <a:xfrm>
            <a:off x="1371599" y="1028700"/>
            <a:ext cx="1295400" cy="550247"/>
          </a:xfrm>
          <a:prstGeom prst="diamond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Cu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1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1371599" y="1638300"/>
            <a:ext cx="1295400" cy="550247"/>
          </a:xfrm>
          <a:prstGeom prst="diamond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Cu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2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1371599" y="2247900"/>
            <a:ext cx="1295400" cy="550247"/>
          </a:xfrm>
          <a:prstGeom prst="diamond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Cu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3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990599" y="342900"/>
            <a:ext cx="2057400" cy="415498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300" b="1" i="1" dirty="0" err="1" smtClean="0">
                <a:latin typeface="Arial" pitchFamily="34" charset="0"/>
                <a:cs typeface="Arial" pitchFamily="34" charset="0"/>
              </a:rPr>
              <a:t>t</a:t>
            </a:r>
            <a:r>
              <a:rPr lang="de-DE" sz="1300" b="1" i="1" baseline="-25000" dirty="0" err="1" smtClean="0">
                <a:latin typeface="Arial" pitchFamily="34" charset="0"/>
                <a:cs typeface="Arial" pitchFamily="34" charset="0"/>
              </a:rPr>
              <a:t>n</a:t>
            </a:r>
            <a:endParaRPr lang="de-DE" sz="1300" b="1" i="1" baseline="-25000" dirty="0" smtClean="0">
              <a:latin typeface="Arial" pitchFamily="34" charset="0"/>
              <a:cs typeface="Arial" pitchFamily="34" charset="0"/>
            </a:endParaRP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Rechteck 71"/>
          <p:cNvSpPr/>
          <p:nvPr/>
        </p:nvSpPr>
        <p:spPr>
          <a:xfrm>
            <a:off x="3200399" y="876300"/>
            <a:ext cx="2057400" cy="2667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3" name="Textfeld 72"/>
          <p:cNvSpPr txBox="1"/>
          <p:nvPr/>
        </p:nvSpPr>
        <p:spPr>
          <a:xfrm>
            <a:off x="3581399" y="1028700"/>
            <a:ext cx="1295400" cy="550247"/>
          </a:xfrm>
          <a:prstGeom prst="diamond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Cu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1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3581399" y="1638300"/>
            <a:ext cx="1295400" cy="550247"/>
          </a:xfrm>
          <a:prstGeom prst="diamond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Cu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2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3581399" y="2247900"/>
            <a:ext cx="1295400" cy="550247"/>
          </a:xfrm>
          <a:prstGeom prst="diamond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Cu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3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3200399" y="342900"/>
            <a:ext cx="2057400" cy="415498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300" b="1" i="1" dirty="0" smtClean="0">
                <a:latin typeface="Arial" pitchFamily="34" charset="0"/>
                <a:cs typeface="Arial" pitchFamily="34" charset="0"/>
              </a:rPr>
              <a:t>t</a:t>
            </a:r>
            <a:r>
              <a:rPr lang="de-DE" sz="1300" b="1" i="1" baseline="-25000" dirty="0" smtClean="0">
                <a:latin typeface="Arial" pitchFamily="34" charset="0"/>
                <a:cs typeface="Arial" pitchFamily="34" charset="0"/>
              </a:rPr>
              <a:t>n</a:t>
            </a:r>
            <a:r>
              <a:rPr lang="de-DE" sz="1300" b="1" baseline="-25000" dirty="0" smtClean="0">
                <a:latin typeface="Arial" pitchFamily="34" charset="0"/>
                <a:cs typeface="Arial" pitchFamily="34" charset="0"/>
              </a:rPr>
              <a:t>+1</a:t>
            </a: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Rechteck 76"/>
          <p:cNvSpPr/>
          <p:nvPr/>
        </p:nvSpPr>
        <p:spPr>
          <a:xfrm>
            <a:off x="5410199" y="876300"/>
            <a:ext cx="2057400" cy="2667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8" name="Textfeld 77"/>
          <p:cNvSpPr txBox="1"/>
          <p:nvPr/>
        </p:nvSpPr>
        <p:spPr>
          <a:xfrm>
            <a:off x="5791199" y="1028700"/>
            <a:ext cx="1295400" cy="550247"/>
          </a:xfrm>
          <a:prstGeom prst="diamond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Cu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1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Textfeld 79"/>
          <p:cNvSpPr txBox="1"/>
          <p:nvPr/>
        </p:nvSpPr>
        <p:spPr>
          <a:xfrm>
            <a:off x="5791199" y="1638300"/>
            <a:ext cx="1295400" cy="550247"/>
          </a:xfrm>
          <a:prstGeom prst="diamond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Cu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2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5791199" y="2247900"/>
            <a:ext cx="1295400" cy="550247"/>
          </a:xfrm>
          <a:prstGeom prst="diamond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Cu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3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5410199" y="342900"/>
            <a:ext cx="2057400" cy="415498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300" b="1" i="1" dirty="0" smtClean="0">
                <a:latin typeface="Arial" pitchFamily="34" charset="0"/>
                <a:cs typeface="Arial" pitchFamily="34" charset="0"/>
              </a:rPr>
              <a:t>t</a:t>
            </a:r>
            <a:r>
              <a:rPr lang="de-DE" sz="1300" b="1" i="1" baseline="-25000" dirty="0" smtClean="0">
                <a:latin typeface="Arial" pitchFamily="34" charset="0"/>
                <a:cs typeface="Arial" pitchFamily="34" charset="0"/>
              </a:rPr>
              <a:t>n</a:t>
            </a:r>
            <a:r>
              <a:rPr lang="de-DE" sz="1300" b="1" baseline="-25000" dirty="0" smtClean="0">
                <a:latin typeface="Arial" pitchFamily="34" charset="0"/>
                <a:cs typeface="Arial" pitchFamily="34" charset="0"/>
              </a:rPr>
              <a:t>+2</a:t>
            </a: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Rechteck 82"/>
          <p:cNvSpPr/>
          <p:nvPr/>
        </p:nvSpPr>
        <p:spPr>
          <a:xfrm>
            <a:off x="7619999" y="876300"/>
            <a:ext cx="2057400" cy="2667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4" name="Textfeld 83"/>
          <p:cNvSpPr txBox="1"/>
          <p:nvPr/>
        </p:nvSpPr>
        <p:spPr>
          <a:xfrm>
            <a:off x="8000999" y="1638300"/>
            <a:ext cx="1295400" cy="550247"/>
          </a:xfrm>
          <a:prstGeom prst="diamond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Cu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2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8000999" y="2247900"/>
            <a:ext cx="1295400" cy="550247"/>
          </a:xfrm>
          <a:prstGeom prst="diamond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Cu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3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Textfeld 85"/>
          <p:cNvSpPr txBox="1"/>
          <p:nvPr/>
        </p:nvSpPr>
        <p:spPr>
          <a:xfrm>
            <a:off x="7619999" y="342900"/>
            <a:ext cx="2057400" cy="415498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300" b="1" i="1" dirty="0" smtClean="0">
                <a:latin typeface="Arial" pitchFamily="34" charset="0"/>
                <a:cs typeface="Arial" pitchFamily="34" charset="0"/>
              </a:rPr>
              <a:t>t</a:t>
            </a:r>
            <a:r>
              <a:rPr lang="de-DE" sz="1300" b="1" i="1" baseline="-25000" dirty="0" smtClean="0">
                <a:latin typeface="Arial" pitchFamily="34" charset="0"/>
                <a:cs typeface="Arial" pitchFamily="34" charset="0"/>
              </a:rPr>
              <a:t>n</a:t>
            </a:r>
            <a:r>
              <a:rPr lang="de-DE" sz="1300" b="1" baseline="-25000" dirty="0" smtClean="0">
                <a:latin typeface="Arial" pitchFamily="34" charset="0"/>
                <a:cs typeface="Arial" pitchFamily="34" charset="0"/>
              </a:rPr>
              <a:t>+3</a:t>
            </a: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3581399" y="2857500"/>
            <a:ext cx="1295400" cy="550247"/>
          </a:xfrm>
          <a:prstGeom prst="diamond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Cu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4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5791199" y="2857500"/>
            <a:ext cx="1295400" cy="550247"/>
          </a:xfrm>
          <a:prstGeom prst="diamond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Cu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4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Pfeil nach rechts 88"/>
          <p:cNvSpPr/>
          <p:nvPr/>
        </p:nvSpPr>
        <p:spPr>
          <a:xfrm>
            <a:off x="2895599" y="1028700"/>
            <a:ext cx="609600" cy="30480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0" name="Pfeil nach rechts 89"/>
          <p:cNvSpPr/>
          <p:nvPr/>
        </p:nvSpPr>
        <p:spPr>
          <a:xfrm>
            <a:off x="7315199" y="1028700"/>
            <a:ext cx="609600" cy="30480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1" name="Textfeld 90"/>
          <p:cNvSpPr txBox="1"/>
          <p:nvPr/>
        </p:nvSpPr>
        <p:spPr>
          <a:xfrm rot="16200000">
            <a:off x="-668552" y="2002051"/>
            <a:ext cx="2667000" cy="415498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sz="1300" b="1" dirty="0" smtClean="0">
                <a:latin typeface="Arial" pitchFamily="34" charset="0"/>
                <a:cs typeface="Arial" pitchFamily="34" charset="0"/>
              </a:rPr>
              <a:t>Objective (Actual) Cues</a:t>
            </a:r>
            <a:endParaRPr lang="en-US" sz="1300" b="1" baseline="-25000" dirty="0" smtClean="0">
              <a:latin typeface="Arial" pitchFamily="34" charset="0"/>
              <a:cs typeface="Arial" pitchFamily="34" charset="0"/>
            </a:endParaRP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Rechteck 91"/>
          <p:cNvSpPr/>
          <p:nvPr/>
        </p:nvSpPr>
        <p:spPr>
          <a:xfrm>
            <a:off x="990599" y="3695700"/>
            <a:ext cx="2057400" cy="3429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3" name="Rechteck 92"/>
          <p:cNvSpPr/>
          <p:nvPr/>
        </p:nvSpPr>
        <p:spPr>
          <a:xfrm>
            <a:off x="5410199" y="3695700"/>
            <a:ext cx="2057400" cy="3429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4" name="Rechteck 93"/>
          <p:cNvSpPr/>
          <p:nvPr/>
        </p:nvSpPr>
        <p:spPr>
          <a:xfrm>
            <a:off x="7619999" y="3695700"/>
            <a:ext cx="2057400" cy="3429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5" name="Textfeld 94"/>
          <p:cNvSpPr txBox="1"/>
          <p:nvPr/>
        </p:nvSpPr>
        <p:spPr>
          <a:xfrm rot="16200000">
            <a:off x="-1049552" y="5202451"/>
            <a:ext cx="3429000" cy="415498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sz="1300" b="1" dirty="0" smtClean="0">
                <a:latin typeface="Arial" pitchFamily="34" charset="0"/>
                <a:cs typeface="Arial" pitchFamily="34" charset="0"/>
              </a:rPr>
              <a:t>Perceived Characteristics</a:t>
            </a:r>
            <a:endParaRPr lang="en-US" sz="1300" b="1" baseline="-25000" dirty="0" smtClean="0">
              <a:latin typeface="Arial" pitchFamily="34" charset="0"/>
              <a:cs typeface="Arial" pitchFamily="34" charset="0"/>
            </a:endParaRP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6" name="Rechteck 95"/>
          <p:cNvSpPr/>
          <p:nvPr/>
        </p:nvSpPr>
        <p:spPr>
          <a:xfrm>
            <a:off x="2666999" y="4076700"/>
            <a:ext cx="152400" cy="228600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7" name="Rechteck 96"/>
          <p:cNvSpPr/>
          <p:nvPr/>
        </p:nvSpPr>
        <p:spPr>
          <a:xfrm>
            <a:off x="2590799" y="4991100"/>
            <a:ext cx="152400" cy="4286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8" name="Textfeld 97"/>
          <p:cNvSpPr txBox="1"/>
          <p:nvPr/>
        </p:nvSpPr>
        <p:spPr>
          <a:xfrm>
            <a:off x="1219199" y="5419755"/>
            <a:ext cx="1524000" cy="400110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Characteristic b</a:t>
            </a: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9" name="Rechteck 98"/>
          <p:cNvSpPr/>
          <p:nvPr/>
        </p:nvSpPr>
        <p:spPr>
          <a:xfrm>
            <a:off x="4876799" y="4076700"/>
            <a:ext cx="152400" cy="228600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0" name="Rechteck 99"/>
          <p:cNvSpPr/>
          <p:nvPr/>
        </p:nvSpPr>
        <p:spPr>
          <a:xfrm>
            <a:off x="4800599" y="4991100"/>
            <a:ext cx="152400" cy="4286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1" name="Textfeld 100"/>
          <p:cNvSpPr txBox="1"/>
          <p:nvPr/>
        </p:nvSpPr>
        <p:spPr>
          <a:xfrm>
            <a:off x="3428999" y="5419755"/>
            <a:ext cx="1524000" cy="400110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Characteristic b</a:t>
            </a: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" name="Rechteck 101"/>
          <p:cNvSpPr/>
          <p:nvPr/>
        </p:nvSpPr>
        <p:spPr>
          <a:xfrm>
            <a:off x="4800599" y="6057900"/>
            <a:ext cx="152400" cy="4286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3" name="Textfeld 102"/>
          <p:cNvSpPr txBox="1"/>
          <p:nvPr/>
        </p:nvSpPr>
        <p:spPr>
          <a:xfrm>
            <a:off x="3428999" y="6486555"/>
            <a:ext cx="1524000" cy="400110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Characteristic c</a:t>
            </a: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4" name="Rechteck 103"/>
          <p:cNvSpPr/>
          <p:nvPr/>
        </p:nvSpPr>
        <p:spPr>
          <a:xfrm>
            <a:off x="7086599" y="4076700"/>
            <a:ext cx="152400" cy="228600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5" name="Rechteck 104"/>
          <p:cNvSpPr/>
          <p:nvPr/>
        </p:nvSpPr>
        <p:spPr>
          <a:xfrm>
            <a:off x="7010399" y="4991100"/>
            <a:ext cx="152400" cy="4286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6" name="Textfeld 105"/>
          <p:cNvSpPr txBox="1"/>
          <p:nvPr/>
        </p:nvSpPr>
        <p:spPr>
          <a:xfrm>
            <a:off x="5638799" y="5419755"/>
            <a:ext cx="1524000" cy="400110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Characteristic b</a:t>
            </a: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Rechteck 106"/>
          <p:cNvSpPr/>
          <p:nvPr/>
        </p:nvSpPr>
        <p:spPr>
          <a:xfrm>
            <a:off x="7010399" y="6057900"/>
            <a:ext cx="152400" cy="4286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8" name="Textfeld 107"/>
          <p:cNvSpPr txBox="1"/>
          <p:nvPr/>
        </p:nvSpPr>
        <p:spPr>
          <a:xfrm>
            <a:off x="5638799" y="6486555"/>
            <a:ext cx="1524000" cy="400110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Characteristic c</a:t>
            </a: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9" name="Rechteck 108"/>
          <p:cNvSpPr/>
          <p:nvPr/>
        </p:nvSpPr>
        <p:spPr>
          <a:xfrm>
            <a:off x="9296399" y="3924300"/>
            <a:ext cx="152400" cy="381000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0" name="Rechteck 109"/>
          <p:cNvSpPr/>
          <p:nvPr/>
        </p:nvSpPr>
        <p:spPr>
          <a:xfrm>
            <a:off x="9220199" y="5295900"/>
            <a:ext cx="152400" cy="1238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1" name="Textfeld 110"/>
          <p:cNvSpPr txBox="1"/>
          <p:nvPr/>
        </p:nvSpPr>
        <p:spPr>
          <a:xfrm>
            <a:off x="7848599" y="5419755"/>
            <a:ext cx="1524000" cy="400110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Characteristic b</a:t>
            </a: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" name="Rechteck 111"/>
          <p:cNvSpPr/>
          <p:nvPr/>
        </p:nvSpPr>
        <p:spPr>
          <a:xfrm>
            <a:off x="9220199" y="6286500"/>
            <a:ext cx="152400" cy="2000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3" name="Textfeld 112"/>
          <p:cNvSpPr txBox="1"/>
          <p:nvPr/>
        </p:nvSpPr>
        <p:spPr>
          <a:xfrm>
            <a:off x="7848599" y="6486555"/>
            <a:ext cx="1524000" cy="400110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Characteristic c</a:t>
            </a: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4" name="Pfeil nach rechts 113"/>
          <p:cNvSpPr/>
          <p:nvPr/>
        </p:nvSpPr>
        <p:spPr>
          <a:xfrm>
            <a:off x="2895599" y="3848100"/>
            <a:ext cx="609600" cy="30480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5" name="Pfeil nach rechts 114"/>
          <p:cNvSpPr/>
          <p:nvPr/>
        </p:nvSpPr>
        <p:spPr>
          <a:xfrm>
            <a:off x="7315199" y="3848100"/>
            <a:ext cx="609600" cy="30480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6" name="Rechteck 115"/>
          <p:cNvSpPr/>
          <p:nvPr/>
        </p:nvSpPr>
        <p:spPr>
          <a:xfrm>
            <a:off x="990600" y="7277100"/>
            <a:ext cx="2057400" cy="28194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7" name="Textfeld 116"/>
          <p:cNvSpPr txBox="1"/>
          <p:nvPr/>
        </p:nvSpPr>
        <p:spPr>
          <a:xfrm>
            <a:off x="1295399" y="8267700"/>
            <a:ext cx="1295399" cy="670828"/>
          </a:xfrm>
          <a:prstGeom prst="ellipse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endParaRPr lang="de-DE" sz="7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Class A</a:t>
            </a:r>
          </a:p>
          <a:p>
            <a:pPr algn="ctr"/>
            <a:endParaRPr lang="de-DE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8" name="Rechteck 117"/>
          <p:cNvSpPr/>
          <p:nvPr/>
        </p:nvSpPr>
        <p:spPr>
          <a:xfrm>
            <a:off x="3200400" y="7277100"/>
            <a:ext cx="2057400" cy="28194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9" name="Rechteck 118"/>
          <p:cNvSpPr/>
          <p:nvPr/>
        </p:nvSpPr>
        <p:spPr>
          <a:xfrm>
            <a:off x="5410200" y="7277100"/>
            <a:ext cx="2057400" cy="28194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0" name="Rechteck 119"/>
          <p:cNvSpPr/>
          <p:nvPr/>
        </p:nvSpPr>
        <p:spPr>
          <a:xfrm>
            <a:off x="7620000" y="7277100"/>
            <a:ext cx="2057400" cy="28194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1" name="Textfeld 120"/>
          <p:cNvSpPr txBox="1"/>
          <p:nvPr/>
        </p:nvSpPr>
        <p:spPr>
          <a:xfrm rot="16200000">
            <a:off x="-744751" y="8479051"/>
            <a:ext cx="2819400" cy="415498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sz="1300" b="1" dirty="0" smtClean="0">
                <a:latin typeface="Arial" pitchFamily="34" charset="0"/>
                <a:cs typeface="Arial" pitchFamily="34" charset="0"/>
              </a:rPr>
              <a:t>Class Categorization</a:t>
            </a:r>
            <a:endParaRPr lang="en-US" sz="1300" b="1" baseline="-25000" dirty="0" smtClean="0">
              <a:latin typeface="Arial" pitchFamily="34" charset="0"/>
              <a:cs typeface="Arial" pitchFamily="34" charset="0"/>
            </a:endParaRP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2" name="Textfeld 121"/>
          <p:cNvSpPr txBox="1"/>
          <p:nvPr/>
        </p:nvSpPr>
        <p:spPr>
          <a:xfrm>
            <a:off x="3581399" y="8267700"/>
            <a:ext cx="1295399" cy="670828"/>
          </a:xfrm>
          <a:prstGeom prst="ellipse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endParaRPr lang="de-DE" sz="7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Class A</a:t>
            </a:r>
          </a:p>
          <a:p>
            <a:pPr algn="ctr"/>
            <a:endParaRPr lang="de-DE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3" name="Textfeld 122"/>
          <p:cNvSpPr txBox="1"/>
          <p:nvPr/>
        </p:nvSpPr>
        <p:spPr>
          <a:xfrm>
            <a:off x="5714999" y="8267700"/>
            <a:ext cx="1295399" cy="670828"/>
          </a:xfrm>
          <a:prstGeom prst="ellipse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endParaRPr lang="de-DE" sz="7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Class A</a:t>
            </a:r>
          </a:p>
          <a:p>
            <a:pPr algn="ctr"/>
            <a:endParaRPr lang="de-DE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4" name="Textfeld 123"/>
          <p:cNvSpPr txBox="1"/>
          <p:nvPr/>
        </p:nvSpPr>
        <p:spPr>
          <a:xfrm>
            <a:off x="8077200" y="8267700"/>
            <a:ext cx="1295399" cy="670828"/>
          </a:xfrm>
          <a:prstGeom prst="ellipse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endParaRPr lang="de-DE" sz="7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Class B</a:t>
            </a:r>
          </a:p>
          <a:p>
            <a:pPr algn="ctr"/>
            <a:endParaRPr lang="de-DE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5" name="Pfeil nach rechts 124"/>
          <p:cNvSpPr/>
          <p:nvPr/>
        </p:nvSpPr>
        <p:spPr>
          <a:xfrm>
            <a:off x="7315199" y="7429500"/>
            <a:ext cx="609600" cy="30480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6" name="Textfeld 125"/>
          <p:cNvSpPr txBox="1"/>
          <p:nvPr/>
        </p:nvSpPr>
        <p:spPr>
          <a:xfrm>
            <a:off x="3428999" y="4305300"/>
            <a:ext cx="1600200" cy="400110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Characteristic a</a:t>
            </a: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7" name="Textfeld 126"/>
          <p:cNvSpPr txBox="1"/>
          <p:nvPr/>
        </p:nvSpPr>
        <p:spPr>
          <a:xfrm>
            <a:off x="5638799" y="4305300"/>
            <a:ext cx="1600200" cy="400110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Characteristic a</a:t>
            </a: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8" name="Textfeld 127"/>
          <p:cNvSpPr txBox="1"/>
          <p:nvPr/>
        </p:nvSpPr>
        <p:spPr>
          <a:xfrm>
            <a:off x="7848599" y="4305300"/>
            <a:ext cx="1600200" cy="400110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Characteristic a</a:t>
            </a: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9" name="Textfeld 128"/>
          <p:cNvSpPr txBox="1"/>
          <p:nvPr/>
        </p:nvSpPr>
        <p:spPr>
          <a:xfrm>
            <a:off x="1219199" y="4305300"/>
            <a:ext cx="1600200" cy="400110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Characteristic a</a:t>
            </a: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0" name="Textfeld 129"/>
          <p:cNvSpPr txBox="1"/>
          <p:nvPr/>
        </p:nvSpPr>
        <p:spPr>
          <a:xfrm>
            <a:off x="1219199" y="6486555"/>
            <a:ext cx="1524000" cy="400110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endParaRPr lang="de-DE" sz="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Characteristic c</a:t>
            </a:r>
          </a:p>
          <a:p>
            <a:pPr algn="ctr"/>
            <a:endParaRPr lang="de-DE" sz="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Office PowerPoint</Application>
  <PresentationFormat>Benutzerdefiniert</PresentationFormat>
  <Paragraphs>5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-Design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JFR</dc:creator>
  <cp:lastModifiedBy>John Rauthmann</cp:lastModifiedBy>
  <cp:revision>11</cp:revision>
  <dcterms:created xsi:type="dcterms:W3CDTF">2015-06-21T21:34:49Z</dcterms:created>
  <dcterms:modified xsi:type="dcterms:W3CDTF">2015-07-15T14:41:21Z</dcterms:modified>
</cp:coreProperties>
</file>